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355" r:id="rId2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109" autoAdjust="0"/>
    <p:restoredTop sz="86709" autoAdjust="0"/>
  </p:normalViewPr>
  <p:slideViewPr>
    <p:cSldViewPr snapToGrid="0">
      <p:cViewPr varScale="1">
        <p:scale>
          <a:sx n="176" d="100"/>
          <a:sy n="176" d="100"/>
        </p:scale>
        <p:origin x="2268" y="1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448" cy="497438"/>
          </a:xfrm>
          <a:prstGeom prst="rect">
            <a:avLst/>
          </a:prstGeom>
        </p:spPr>
        <p:txBody>
          <a:bodyPr vert="horz" lIns="90955" tIns="45478" rIns="90955" bIns="45478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1227" y="0"/>
            <a:ext cx="2944869" cy="497438"/>
          </a:xfrm>
          <a:prstGeom prst="rect">
            <a:avLst/>
          </a:prstGeom>
        </p:spPr>
        <p:txBody>
          <a:bodyPr vert="horz" lIns="90955" tIns="45478" rIns="90955" bIns="45478" rtlCol="0"/>
          <a:lstStyle>
            <a:lvl1pPr algn="r">
              <a:defRPr sz="1200"/>
            </a:lvl1pPr>
          </a:lstStyle>
          <a:p>
            <a:fld id="{C8D3F816-7643-4521-998F-F5B880B5C112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9429201"/>
            <a:ext cx="2946448" cy="497437"/>
          </a:xfrm>
          <a:prstGeom prst="rect">
            <a:avLst/>
          </a:prstGeom>
        </p:spPr>
        <p:txBody>
          <a:bodyPr vert="horz" lIns="90955" tIns="45478" rIns="90955" bIns="45478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1227" y="9429201"/>
            <a:ext cx="2944869" cy="497437"/>
          </a:xfrm>
          <a:prstGeom prst="rect">
            <a:avLst/>
          </a:prstGeom>
        </p:spPr>
        <p:txBody>
          <a:bodyPr vert="horz" lIns="90955" tIns="45478" rIns="90955" bIns="45478" rtlCol="0" anchor="b"/>
          <a:lstStyle>
            <a:lvl1pPr algn="r">
              <a:defRPr sz="1200"/>
            </a:lvl1pPr>
          </a:lstStyle>
          <a:p>
            <a:fld id="{6ED6ED14-8A07-49A0-A8C9-8C3467E1FA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828767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0955" tIns="45478" rIns="90955" bIns="45478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0955" tIns="45478" rIns="90955" bIns="45478" rtlCol="0"/>
          <a:lstStyle>
            <a:lvl1pPr algn="r">
              <a:defRPr sz="1200"/>
            </a:lvl1pPr>
          </a:lstStyle>
          <a:p>
            <a:fld id="{97E01E98-46B2-4FDC-BD64-567B53DD4BA2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955" tIns="45478" rIns="90955" bIns="45478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0955" tIns="45478" rIns="90955" bIns="45478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0955" tIns="45478" rIns="90955" bIns="45478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0955" tIns="45478" rIns="90955" bIns="45478" rtlCol="0" anchor="b"/>
          <a:lstStyle>
            <a:lvl1pPr algn="r">
              <a:defRPr sz="1200"/>
            </a:lvl1pPr>
          </a:lstStyle>
          <a:p>
            <a:fld id="{4416290E-022E-471A-9418-12ED7E6117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2900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16290E-022E-471A-9418-12ED7E61173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52103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2408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4579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9696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8301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7514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1982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40045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6720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2629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4064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5448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A381E-DB91-4900-8F00-42EC8DF196BF}" type="datetimeFigureOut">
              <a:rPr lang="ko-KR" altLang="en-US" smtClean="0"/>
              <a:t>2017-08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C6776-EB7D-4FD9-90BF-28DE534BB8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0124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98291" y="82172"/>
            <a:ext cx="52757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1. Anti-Oxidant Discovery Scoring Data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1150418"/>
              </p:ext>
            </p:extLst>
          </p:nvPr>
        </p:nvGraphicFramePr>
        <p:xfrm>
          <a:off x="-5" y="527250"/>
          <a:ext cx="9144006" cy="633075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24701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740619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12"/>
                    </a:ext>
                  </a:extLst>
                </a:gridCol>
                <a:gridCol w="472520">
                  <a:extLst>
                    <a:ext uri="{9D8B030D-6E8A-4147-A177-3AD203B41FA5}">
                      <a16:colId xmlns="" xmlns:a16="http://schemas.microsoft.com/office/drawing/2014/main" val="20013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14"/>
                    </a:ext>
                  </a:extLst>
                </a:gridCol>
                <a:gridCol w="652937">
                  <a:extLst>
                    <a:ext uri="{9D8B030D-6E8A-4147-A177-3AD203B41FA5}">
                      <a16:colId xmlns="" xmlns:a16="http://schemas.microsoft.com/office/drawing/2014/main" val="20015"/>
                    </a:ext>
                  </a:extLst>
                </a:gridCol>
                <a:gridCol w="504022">
                  <a:extLst>
                    <a:ext uri="{9D8B030D-6E8A-4147-A177-3AD203B41FA5}">
                      <a16:colId xmlns="" xmlns:a16="http://schemas.microsoft.com/office/drawing/2014/main" val="20016"/>
                    </a:ext>
                  </a:extLst>
                </a:gridCol>
                <a:gridCol w="446748">
                  <a:extLst>
                    <a:ext uri="{9D8B030D-6E8A-4147-A177-3AD203B41FA5}">
                      <a16:colId xmlns="" xmlns:a16="http://schemas.microsoft.com/office/drawing/2014/main" val="20017"/>
                    </a:ext>
                  </a:extLst>
                </a:gridCol>
                <a:gridCol w="641483">
                  <a:extLst>
                    <a:ext uri="{9D8B030D-6E8A-4147-A177-3AD203B41FA5}">
                      <a16:colId xmlns="" xmlns:a16="http://schemas.microsoft.com/office/drawing/2014/main" val="20018"/>
                    </a:ext>
                  </a:extLst>
                </a:gridCol>
              </a:tblGrid>
              <a:tr h="6612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/z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M-H]</a:t>
                      </a:r>
                      <a:r>
                        <a:rPr lang="en-US" sz="10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0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</a:t>
                      </a:r>
                      <a:r>
                        <a:rPr lang="ko-KR" alt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ction </a:t>
                      </a:r>
                      <a:b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Cent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ctions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rtl="0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j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nsity</a:t>
                      </a:r>
                    </a:p>
                    <a:p>
                      <a:pPr algn="ctr" rtl="0" fontAlgn="ctr"/>
                      <a:r>
                        <a:rPr lang="en-US" sz="9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ndard </a:t>
                      </a:r>
                      <a:b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via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ore 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Oxidant</a:t>
                      </a:r>
                      <a:b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ndar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7.0459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8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1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9E+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60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7.217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9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3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6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4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7E+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1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1.03538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1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1E+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8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Ox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5.150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4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3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E+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6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3.0878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6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2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1E+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2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Ox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6.12452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9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9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0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2E+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1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5.0772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9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7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1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0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E+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4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1.0611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8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4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1E+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2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.0772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3E+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6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5.1289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4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8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2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1E+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50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9.1714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6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0E+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9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9.0988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6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5E+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6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7.1289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7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9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1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4E+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7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5.0404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9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5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E+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3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Ox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3.0510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3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5E+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6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Ox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1.0725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5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2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6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E+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9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9.1461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8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5E+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30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Ox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7.05104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5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2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ko-KR" alt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.7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E+09</a:t>
                      </a:r>
                      <a:endParaRPr lang="en-US" altLang="ko-KR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12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B w="12700" cmpd="sng"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1.22316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4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1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6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ko-KR" alt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2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2E+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88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  <a:tr h="26965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3.1333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9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2E+0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2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92591661"/>
                  </a:ext>
                </a:extLst>
              </a:tr>
              <a:tr h="276507"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vity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1</a:t>
                      </a:r>
                      <a:endParaRPr lang="en-US" altLang="ko-KR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3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9</a:t>
                      </a:r>
                      <a:endParaRPr lang="en-US" altLang="ko-KR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2</a:t>
                      </a:r>
                      <a:endParaRPr lang="en-US" altLang="ko-KR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5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…..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3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3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4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5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ko-KR" alt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412" marR="7412" marT="741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84292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87</TotalTime>
  <Words>409</Words>
  <Application>Microsoft Office PowerPoint</Application>
  <PresentationFormat>화면 슬라이드 쇼(4:3)</PresentationFormat>
  <Paragraphs>420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성시현</dc:creator>
  <cp:lastModifiedBy>KHS</cp:lastModifiedBy>
  <cp:revision>242</cp:revision>
  <cp:lastPrinted>2017-08-17T05:45:10Z</cp:lastPrinted>
  <dcterms:created xsi:type="dcterms:W3CDTF">2017-05-09T13:56:55Z</dcterms:created>
  <dcterms:modified xsi:type="dcterms:W3CDTF">2017-08-21T07:01:48Z</dcterms:modified>
</cp:coreProperties>
</file>